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12192000" cy="6858000"/>
  <p:notesSz cx="6858000" cy="9144000"/>
  <p:custDataLst>
    <p:tags r:id="rId12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presProps" Target="presProps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2" Type="http://schemas.openxmlformats.org/officeDocument/2006/relationships/tags" Target="tags/tag1.xml"/><Relationship Id="rId11" Type="http://schemas.openxmlformats.org/officeDocument/2006/relationships/tableStyles" Target="tableStyles.xml"/><Relationship Id="rId10" Type="http://schemas.openxmlformats.org/officeDocument/2006/relationships/viewProps" Target="viewProps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FigS1：Mixed signal intensity of LPLN 异质性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66975" y="2254250"/>
            <a:ext cx="7258050" cy="152400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3048000" y="4155440"/>
            <a:ext cx="60960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ctr"/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FigS1：Mixed signal intensity of LPLN</a:t>
            </a:r>
            <a:endParaRPr lang="zh-CN" altLang="en-US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文本框 4"/>
          <p:cNvSpPr txBox="1"/>
          <p:nvPr/>
        </p:nvSpPr>
        <p:spPr>
          <a:xfrm>
            <a:off x="3048000" y="4155440"/>
            <a:ext cx="60960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ctr"/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FigS2：SA 8mm before CRT</a:t>
            </a:r>
            <a:endParaRPr lang="zh-CN" altLang="en-US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 descr="FigS2：SA 8mm before CRT 异质性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811145" y="1986280"/>
            <a:ext cx="7258050" cy="1981200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文本框 4"/>
          <p:cNvSpPr txBox="1"/>
          <p:nvPr/>
        </p:nvSpPr>
        <p:spPr>
          <a:xfrm>
            <a:off x="3048000" y="4155440"/>
            <a:ext cx="60960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ctr"/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FigS3：cN</a:t>
            </a:r>
            <a:endParaRPr lang="zh-CN" altLang="en-US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 descr="FigS3：cN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672715" y="1920875"/>
            <a:ext cx="7096125" cy="1828800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文本框 4"/>
          <p:cNvSpPr txBox="1"/>
          <p:nvPr/>
        </p:nvSpPr>
        <p:spPr>
          <a:xfrm>
            <a:off x="3048000" y="4155440"/>
            <a:ext cx="60960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ctr"/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FigS4：pT</a:t>
            </a:r>
            <a:endParaRPr lang="zh-CN" altLang="en-US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 descr="FigS4：pT 异质性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357755" y="627380"/>
            <a:ext cx="7258050" cy="3352800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文本框 4"/>
          <p:cNvSpPr txBox="1"/>
          <p:nvPr/>
        </p:nvSpPr>
        <p:spPr>
          <a:xfrm>
            <a:off x="3048000" y="4155440"/>
            <a:ext cx="60960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ctr"/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FigS5：pN</a:t>
            </a:r>
            <a:endParaRPr lang="zh-CN" altLang="en-US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 descr="FigS5：pN 有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718435" y="1295400"/>
            <a:ext cx="7162800" cy="2133600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文本框 4"/>
          <p:cNvSpPr txBox="1"/>
          <p:nvPr/>
        </p:nvSpPr>
        <p:spPr>
          <a:xfrm>
            <a:off x="3048000" y="4155440"/>
            <a:ext cx="60960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ctr"/>
            <a:r>
              <a:rPr lang="zh-CN" altLang="en-US">
                <a:latin typeface="Times New Roman" panose="02020603050405020304" charset="0"/>
                <a:cs typeface="Times New Roman" panose="02020603050405020304" charset="0"/>
              </a:rPr>
              <a:t>FigS6：PI</a:t>
            </a:r>
            <a:endParaRPr lang="zh-CN" altLang="en-US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 descr="FigS6：PI 异质性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66975" y="1271905"/>
            <a:ext cx="7258050" cy="2438400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YzQxMDlkNWY5ZTQ3NDVhYjkwOTVlMWRkMmU4Yjk5Y2Q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1</Words>
  <Application>WPS 演示</Application>
  <PresentationFormat>宽屏</PresentationFormat>
  <Paragraphs>12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4" baseType="lpstr">
      <vt:lpstr>Arial</vt:lpstr>
      <vt:lpstr>宋体</vt:lpstr>
      <vt:lpstr>Wingdings</vt:lpstr>
      <vt:lpstr>Arial Unicode MS</vt:lpstr>
      <vt:lpstr>Calibri</vt:lpstr>
      <vt:lpstr>微软雅黑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Zilch</cp:lastModifiedBy>
  <cp:revision>2</cp:revision>
  <dcterms:created xsi:type="dcterms:W3CDTF">2023-05-09T08:01:55Z</dcterms:created>
  <dcterms:modified xsi:type="dcterms:W3CDTF">2023-05-09T08:07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CBFB104CDAB1473797A8F3BAFF2F28D6_12</vt:lpwstr>
  </property>
  <property fmtid="{D5CDD505-2E9C-101B-9397-08002B2CF9AE}" pid="3" name="KSOProductBuildVer">
    <vt:lpwstr>2052-11.1.0.14309</vt:lpwstr>
  </property>
</Properties>
</file>